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F583F3-19E1-4D59-94E3-D57EB099EA37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40D346-0C44-4F86-A22B-A59F4CDB9C4D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8435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/>
          <a:lstStyle/>
          <a:p>
            <a:endParaRPr lang="en-US" smtClean="0">
              <a:ea typeface="ＭＳ Ｐゴシック" pitchFamily="34" charset="-128"/>
            </a:endParaRPr>
          </a:p>
        </p:txBody>
      </p:sp>
      <p:sp>
        <p:nvSpPr>
          <p:cNvPr id="18436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8C30BE42-951A-499D-AEC5-0B06FF8D00CD}" type="slidenum">
              <a:rPr lang="en-GB" smtClean="0">
                <a:latin typeface="Arial" pitchFamily="34" charset="0"/>
                <a:ea typeface="ＭＳ Ｐゴシック" pitchFamily="34" charset="-128"/>
              </a:rPr>
              <a:pPr/>
              <a:t>1</a:t>
            </a:fld>
            <a:endParaRPr lang="en-GB" smtClean="0">
              <a:latin typeface="Arial" pitchFamily="34" charset="0"/>
              <a:ea typeface="ＭＳ Ｐゴシック" pitchFamily="34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13326-7503-49F4-9776-B8BA9711CBD3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8FDB00-A053-493A-9309-7E6CAC6FFFF4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Text Box 4"/>
          <p:cNvSpPr txBox="1">
            <a:spLocks noChangeArrowheads="1"/>
          </p:cNvSpPr>
          <p:nvPr/>
        </p:nvSpPr>
        <p:spPr bwMode="auto">
          <a:xfrm>
            <a:off x="0" y="0"/>
            <a:ext cx="245515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/>
              <a:t>Supplementary Table-S2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827618" y="404813"/>
          <a:ext cx="7968884" cy="785812"/>
        </p:xfrm>
        <a:graphic>
          <a:graphicData uri="http://schemas.openxmlformats.org/drawingml/2006/table">
            <a:tbl>
              <a:tblPr/>
              <a:tblGrid>
                <a:gridCol w="896804"/>
                <a:gridCol w="1234807"/>
                <a:gridCol w="1347063"/>
                <a:gridCol w="2089945"/>
                <a:gridCol w="2400265"/>
              </a:tblGrid>
              <a:tr h="23574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GENE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ORIGIN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Catalogue  number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Sequence</a:t>
                      </a:r>
                      <a:r>
                        <a:rPr lang="en-GB" sz="800" b="1" i="0" u="none" strike="noStrike" baseline="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 primer F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Sequence primer R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751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TGM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latin typeface="Calibri"/>
                        </a:rPr>
                        <a:t>Qiage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kern="1200" baseline="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QT0008127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ot provide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ot provide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751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ITGA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latin typeface="Calibri"/>
                        </a:rPr>
                        <a:t>Qiage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kern="1200" baseline="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QT0008087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ot provide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ot provide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751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ITGB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Primer</a:t>
                      </a:r>
                      <a:r>
                        <a:rPr lang="en-GB" sz="800" b="0" i="0" u="none" strike="noStrike" baseline="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 Ban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CTACTTCTGCACGATGTGATG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CTTTGCTACGGTTGGTTACATT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751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FN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err="1" smtClean="0">
                          <a:solidFill>
                            <a:srgbClr val="000000"/>
                          </a:solidFill>
                          <a:latin typeface="Calibri"/>
                        </a:rPr>
                        <a:t>PrimerBank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GGTGGCTGTCAGTCAAAG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AACCTCGGCTTCCTCCATAA</a:t>
                      </a:r>
                    </a:p>
                  </a:txBody>
                  <a:tcPr marL="12700" marR="12700" marT="7144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On-screen Show (4:3)</PresentationFormat>
  <Paragraphs>2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hadevan.v</dc:creator>
  <cp:lastModifiedBy>mahadevan.v</cp:lastModifiedBy>
  <cp:revision>1</cp:revision>
  <dcterms:created xsi:type="dcterms:W3CDTF">2013-06-24T07:29:08Z</dcterms:created>
  <dcterms:modified xsi:type="dcterms:W3CDTF">2013-06-24T07:29:21Z</dcterms:modified>
</cp:coreProperties>
</file>